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45" d="100"/>
          <a:sy n="45" d="100"/>
        </p:scale>
        <p:origin x="2346" y="6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B2D615-FC73-4476-9D2E-C2710C5374F9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FAE277-F873-4556-80D5-5840C9FDFD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7246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15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4307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1461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861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5769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2923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0077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7231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6259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3130">
                <a:solidFill>
                  <a:schemeClr val="tx1">
                    <a:tint val="75000"/>
                  </a:schemeClr>
                </a:solidFill>
              </a:defRPr>
            </a:lvl1pPr>
            <a:lvl2pPr marL="715390" indent="0">
              <a:buNone/>
              <a:defRPr sz="2817">
                <a:solidFill>
                  <a:schemeClr val="tx1">
                    <a:tint val="75000"/>
                  </a:schemeClr>
                </a:solidFill>
              </a:defRPr>
            </a:lvl2pPr>
            <a:lvl3pPr marL="1430779" indent="0">
              <a:buNone/>
              <a:defRPr sz="2503">
                <a:solidFill>
                  <a:schemeClr val="tx1">
                    <a:tint val="75000"/>
                  </a:schemeClr>
                </a:solidFill>
              </a:defRPr>
            </a:lvl3pPr>
            <a:lvl4pPr marL="2146168" indent="0">
              <a:buNone/>
              <a:defRPr sz="2191">
                <a:solidFill>
                  <a:schemeClr val="tx1">
                    <a:tint val="75000"/>
                  </a:schemeClr>
                </a:solidFill>
              </a:defRPr>
            </a:lvl4pPr>
            <a:lvl5pPr marL="2861557" indent="0">
              <a:buNone/>
              <a:defRPr sz="2191">
                <a:solidFill>
                  <a:schemeClr val="tx1">
                    <a:tint val="75000"/>
                  </a:schemeClr>
                </a:solidFill>
              </a:defRPr>
            </a:lvl5pPr>
            <a:lvl6pPr marL="3576947" indent="0">
              <a:buNone/>
              <a:defRPr sz="2191">
                <a:solidFill>
                  <a:schemeClr val="tx1">
                    <a:tint val="75000"/>
                  </a:schemeClr>
                </a:solidFill>
              </a:defRPr>
            </a:lvl6pPr>
            <a:lvl7pPr marL="4292336" indent="0">
              <a:buNone/>
              <a:defRPr sz="2191">
                <a:solidFill>
                  <a:schemeClr val="tx1">
                    <a:tint val="75000"/>
                  </a:schemeClr>
                </a:solidFill>
              </a:defRPr>
            </a:lvl7pPr>
            <a:lvl8pPr marL="5007725" indent="0">
              <a:buNone/>
              <a:defRPr sz="2191">
                <a:solidFill>
                  <a:schemeClr val="tx1">
                    <a:tint val="75000"/>
                  </a:schemeClr>
                </a:solidFill>
              </a:defRPr>
            </a:lvl8pPr>
            <a:lvl9pPr marL="5723114" indent="0">
              <a:buNone/>
              <a:defRPr sz="21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4381"/>
            </a:lvl1pPr>
            <a:lvl2pPr>
              <a:defRPr sz="3755"/>
            </a:lvl2pPr>
            <a:lvl3pPr>
              <a:defRPr sz="3130"/>
            </a:lvl3pPr>
            <a:lvl4pPr>
              <a:defRPr sz="2817"/>
            </a:lvl4pPr>
            <a:lvl5pPr>
              <a:defRPr sz="2817"/>
            </a:lvl5pPr>
            <a:lvl6pPr>
              <a:defRPr sz="2817"/>
            </a:lvl6pPr>
            <a:lvl7pPr>
              <a:defRPr sz="2817"/>
            </a:lvl7pPr>
            <a:lvl8pPr>
              <a:defRPr sz="2817"/>
            </a:lvl8pPr>
            <a:lvl9pPr>
              <a:defRPr sz="28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4381"/>
            </a:lvl1pPr>
            <a:lvl2pPr>
              <a:defRPr sz="3755"/>
            </a:lvl2pPr>
            <a:lvl3pPr>
              <a:defRPr sz="3130"/>
            </a:lvl3pPr>
            <a:lvl4pPr>
              <a:defRPr sz="2817"/>
            </a:lvl4pPr>
            <a:lvl5pPr>
              <a:defRPr sz="2817"/>
            </a:lvl5pPr>
            <a:lvl6pPr>
              <a:defRPr sz="2817"/>
            </a:lvl6pPr>
            <a:lvl7pPr>
              <a:defRPr sz="2817"/>
            </a:lvl7pPr>
            <a:lvl8pPr>
              <a:defRPr sz="2817"/>
            </a:lvl8pPr>
            <a:lvl9pPr>
              <a:defRPr sz="28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755" b="1"/>
            </a:lvl1pPr>
            <a:lvl2pPr marL="715390" indent="0">
              <a:buNone/>
              <a:defRPr sz="3130" b="1"/>
            </a:lvl2pPr>
            <a:lvl3pPr marL="1430779" indent="0">
              <a:buNone/>
              <a:defRPr sz="2817" b="1"/>
            </a:lvl3pPr>
            <a:lvl4pPr marL="2146168" indent="0">
              <a:buNone/>
              <a:defRPr sz="2503" b="1"/>
            </a:lvl4pPr>
            <a:lvl5pPr marL="2861557" indent="0">
              <a:buNone/>
              <a:defRPr sz="2503" b="1"/>
            </a:lvl5pPr>
            <a:lvl6pPr marL="3576947" indent="0">
              <a:buNone/>
              <a:defRPr sz="2503" b="1"/>
            </a:lvl6pPr>
            <a:lvl7pPr marL="4292336" indent="0">
              <a:buNone/>
              <a:defRPr sz="2503" b="1"/>
            </a:lvl7pPr>
            <a:lvl8pPr marL="5007725" indent="0">
              <a:buNone/>
              <a:defRPr sz="2503" b="1"/>
            </a:lvl8pPr>
            <a:lvl9pPr marL="5723114" indent="0">
              <a:buNone/>
              <a:defRPr sz="25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755"/>
            </a:lvl1pPr>
            <a:lvl2pPr>
              <a:defRPr sz="3130"/>
            </a:lvl2pPr>
            <a:lvl3pPr>
              <a:defRPr sz="2817"/>
            </a:lvl3pPr>
            <a:lvl4pPr>
              <a:defRPr sz="2503"/>
            </a:lvl4pPr>
            <a:lvl5pPr>
              <a:defRPr sz="2503"/>
            </a:lvl5pPr>
            <a:lvl6pPr>
              <a:defRPr sz="2503"/>
            </a:lvl6pPr>
            <a:lvl7pPr>
              <a:defRPr sz="2503"/>
            </a:lvl7pPr>
            <a:lvl8pPr>
              <a:defRPr sz="2503"/>
            </a:lvl8pPr>
            <a:lvl9pPr>
              <a:defRPr sz="250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3755" b="1"/>
            </a:lvl1pPr>
            <a:lvl2pPr marL="715390" indent="0">
              <a:buNone/>
              <a:defRPr sz="3130" b="1"/>
            </a:lvl2pPr>
            <a:lvl3pPr marL="1430779" indent="0">
              <a:buNone/>
              <a:defRPr sz="2817" b="1"/>
            </a:lvl3pPr>
            <a:lvl4pPr marL="2146168" indent="0">
              <a:buNone/>
              <a:defRPr sz="2503" b="1"/>
            </a:lvl4pPr>
            <a:lvl5pPr marL="2861557" indent="0">
              <a:buNone/>
              <a:defRPr sz="2503" b="1"/>
            </a:lvl5pPr>
            <a:lvl6pPr marL="3576947" indent="0">
              <a:buNone/>
              <a:defRPr sz="2503" b="1"/>
            </a:lvl6pPr>
            <a:lvl7pPr marL="4292336" indent="0">
              <a:buNone/>
              <a:defRPr sz="2503" b="1"/>
            </a:lvl7pPr>
            <a:lvl8pPr marL="5007725" indent="0">
              <a:buNone/>
              <a:defRPr sz="2503" b="1"/>
            </a:lvl8pPr>
            <a:lvl9pPr marL="5723114" indent="0">
              <a:buNone/>
              <a:defRPr sz="25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3755"/>
            </a:lvl1pPr>
            <a:lvl2pPr>
              <a:defRPr sz="3130"/>
            </a:lvl2pPr>
            <a:lvl3pPr>
              <a:defRPr sz="2817"/>
            </a:lvl3pPr>
            <a:lvl4pPr>
              <a:defRPr sz="2503"/>
            </a:lvl4pPr>
            <a:lvl5pPr>
              <a:defRPr sz="2503"/>
            </a:lvl5pPr>
            <a:lvl6pPr>
              <a:defRPr sz="2503"/>
            </a:lvl6pPr>
            <a:lvl7pPr>
              <a:defRPr sz="2503"/>
            </a:lvl7pPr>
            <a:lvl8pPr>
              <a:defRPr sz="2503"/>
            </a:lvl8pPr>
            <a:lvl9pPr>
              <a:defRPr sz="250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313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5008"/>
            </a:lvl1pPr>
            <a:lvl2pPr>
              <a:defRPr sz="4381"/>
            </a:lvl2pPr>
            <a:lvl3pPr>
              <a:defRPr sz="3755"/>
            </a:lvl3pPr>
            <a:lvl4pPr>
              <a:defRPr sz="3130"/>
            </a:lvl4pPr>
            <a:lvl5pPr>
              <a:defRPr sz="3130"/>
            </a:lvl5pPr>
            <a:lvl6pPr>
              <a:defRPr sz="3130"/>
            </a:lvl6pPr>
            <a:lvl7pPr>
              <a:defRPr sz="3130"/>
            </a:lvl7pPr>
            <a:lvl8pPr>
              <a:defRPr sz="3130"/>
            </a:lvl8pPr>
            <a:lvl9pPr>
              <a:defRPr sz="313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2191"/>
            </a:lvl1pPr>
            <a:lvl2pPr marL="715390" indent="0">
              <a:buNone/>
              <a:defRPr sz="1878"/>
            </a:lvl2pPr>
            <a:lvl3pPr marL="1430779" indent="0">
              <a:buNone/>
              <a:defRPr sz="1564"/>
            </a:lvl3pPr>
            <a:lvl4pPr marL="2146168" indent="0">
              <a:buNone/>
              <a:defRPr sz="1408"/>
            </a:lvl4pPr>
            <a:lvl5pPr marL="2861557" indent="0">
              <a:buNone/>
              <a:defRPr sz="1408"/>
            </a:lvl5pPr>
            <a:lvl6pPr marL="3576947" indent="0">
              <a:buNone/>
              <a:defRPr sz="1408"/>
            </a:lvl6pPr>
            <a:lvl7pPr marL="4292336" indent="0">
              <a:buNone/>
              <a:defRPr sz="1408"/>
            </a:lvl7pPr>
            <a:lvl8pPr marL="5007725" indent="0">
              <a:buNone/>
              <a:defRPr sz="1408"/>
            </a:lvl8pPr>
            <a:lvl9pPr marL="5723114" indent="0">
              <a:buNone/>
              <a:defRPr sz="140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313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5008"/>
            </a:lvl1pPr>
            <a:lvl2pPr marL="715390" indent="0">
              <a:buNone/>
              <a:defRPr sz="4381"/>
            </a:lvl2pPr>
            <a:lvl3pPr marL="1430779" indent="0">
              <a:buNone/>
              <a:defRPr sz="3755"/>
            </a:lvl3pPr>
            <a:lvl4pPr marL="2146168" indent="0">
              <a:buNone/>
              <a:defRPr sz="3130"/>
            </a:lvl4pPr>
            <a:lvl5pPr marL="2861557" indent="0">
              <a:buNone/>
              <a:defRPr sz="3130"/>
            </a:lvl5pPr>
            <a:lvl6pPr marL="3576947" indent="0">
              <a:buNone/>
              <a:defRPr sz="3130"/>
            </a:lvl6pPr>
            <a:lvl7pPr marL="4292336" indent="0">
              <a:buNone/>
              <a:defRPr sz="3130"/>
            </a:lvl7pPr>
            <a:lvl8pPr marL="5007725" indent="0">
              <a:buNone/>
              <a:defRPr sz="3130"/>
            </a:lvl8pPr>
            <a:lvl9pPr marL="5723114" indent="0">
              <a:buNone/>
              <a:defRPr sz="313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191"/>
            </a:lvl1pPr>
            <a:lvl2pPr marL="715390" indent="0">
              <a:buNone/>
              <a:defRPr sz="1878"/>
            </a:lvl2pPr>
            <a:lvl3pPr marL="1430779" indent="0">
              <a:buNone/>
              <a:defRPr sz="1564"/>
            </a:lvl3pPr>
            <a:lvl4pPr marL="2146168" indent="0">
              <a:buNone/>
              <a:defRPr sz="1408"/>
            </a:lvl4pPr>
            <a:lvl5pPr marL="2861557" indent="0">
              <a:buNone/>
              <a:defRPr sz="1408"/>
            </a:lvl5pPr>
            <a:lvl6pPr marL="3576947" indent="0">
              <a:buNone/>
              <a:defRPr sz="1408"/>
            </a:lvl6pPr>
            <a:lvl7pPr marL="4292336" indent="0">
              <a:buNone/>
              <a:defRPr sz="1408"/>
            </a:lvl7pPr>
            <a:lvl8pPr marL="5007725" indent="0">
              <a:buNone/>
              <a:defRPr sz="1408"/>
            </a:lvl8pPr>
            <a:lvl9pPr marL="5723114" indent="0">
              <a:buNone/>
              <a:defRPr sz="140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430779" rtl="0" eaLnBrk="1" latinLnBrk="0" hangingPunct="1">
        <a:spcBef>
          <a:spcPct val="0"/>
        </a:spcBef>
        <a:buNone/>
        <a:defRPr sz="68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36543" indent="-536543" algn="l" defTabSz="1430779" rtl="0" eaLnBrk="1" latinLnBrk="0" hangingPunct="1">
        <a:spcBef>
          <a:spcPct val="20000"/>
        </a:spcBef>
        <a:buFont typeface="Arial" pitchFamily="34" charset="0"/>
        <a:buChar char="•"/>
        <a:defRPr sz="5008" kern="1200">
          <a:solidFill>
            <a:schemeClr val="tx1"/>
          </a:solidFill>
          <a:latin typeface="+mn-lt"/>
          <a:ea typeface="+mn-ea"/>
          <a:cs typeface="+mn-cs"/>
        </a:defRPr>
      </a:lvl1pPr>
      <a:lvl2pPr marL="1162508" indent="-447118" algn="l" defTabSz="1430779" rtl="0" eaLnBrk="1" latinLnBrk="0" hangingPunct="1">
        <a:spcBef>
          <a:spcPct val="20000"/>
        </a:spcBef>
        <a:buFont typeface="Arial" pitchFamily="34" charset="0"/>
        <a:buChar char="–"/>
        <a:defRPr sz="4381" kern="1200">
          <a:solidFill>
            <a:schemeClr val="tx1"/>
          </a:solidFill>
          <a:latin typeface="+mn-lt"/>
          <a:ea typeface="+mn-ea"/>
          <a:cs typeface="+mn-cs"/>
        </a:defRPr>
      </a:lvl2pPr>
      <a:lvl3pPr marL="1788473" indent="-357694" algn="l" defTabSz="1430779" rtl="0" eaLnBrk="1" latinLnBrk="0" hangingPunct="1">
        <a:spcBef>
          <a:spcPct val="20000"/>
        </a:spcBef>
        <a:buFont typeface="Arial" pitchFamily="34" charset="0"/>
        <a:buChar char="•"/>
        <a:defRPr sz="3755" kern="1200">
          <a:solidFill>
            <a:schemeClr val="tx1"/>
          </a:solidFill>
          <a:latin typeface="+mn-lt"/>
          <a:ea typeface="+mn-ea"/>
          <a:cs typeface="+mn-cs"/>
        </a:defRPr>
      </a:lvl3pPr>
      <a:lvl4pPr marL="2503863" indent="-357694" algn="l" defTabSz="1430779" rtl="0" eaLnBrk="1" latinLnBrk="0" hangingPunct="1">
        <a:spcBef>
          <a:spcPct val="20000"/>
        </a:spcBef>
        <a:buFont typeface="Arial" pitchFamily="34" charset="0"/>
        <a:buChar char="–"/>
        <a:defRPr sz="3130" kern="1200">
          <a:solidFill>
            <a:schemeClr val="tx1"/>
          </a:solidFill>
          <a:latin typeface="+mn-lt"/>
          <a:ea typeface="+mn-ea"/>
          <a:cs typeface="+mn-cs"/>
        </a:defRPr>
      </a:lvl4pPr>
      <a:lvl5pPr marL="3219251" indent="-357694" algn="l" defTabSz="1430779" rtl="0" eaLnBrk="1" latinLnBrk="0" hangingPunct="1">
        <a:spcBef>
          <a:spcPct val="20000"/>
        </a:spcBef>
        <a:buFont typeface="Arial" pitchFamily="34" charset="0"/>
        <a:buChar char="»"/>
        <a:defRPr sz="3130" kern="1200">
          <a:solidFill>
            <a:schemeClr val="tx1"/>
          </a:solidFill>
          <a:latin typeface="+mn-lt"/>
          <a:ea typeface="+mn-ea"/>
          <a:cs typeface="+mn-cs"/>
        </a:defRPr>
      </a:lvl5pPr>
      <a:lvl6pPr marL="3934641" indent="-357694" algn="l" defTabSz="1430779" rtl="0" eaLnBrk="1" latinLnBrk="0" hangingPunct="1">
        <a:spcBef>
          <a:spcPct val="20000"/>
        </a:spcBef>
        <a:buFont typeface="Arial" pitchFamily="34" charset="0"/>
        <a:buChar char="•"/>
        <a:defRPr sz="3130" kern="1200">
          <a:solidFill>
            <a:schemeClr val="tx1"/>
          </a:solidFill>
          <a:latin typeface="+mn-lt"/>
          <a:ea typeface="+mn-ea"/>
          <a:cs typeface="+mn-cs"/>
        </a:defRPr>
      </a:lvl6pPr>
      <a:lvl7pPr marL="4650031" indent="-357694" algn="l" defTabSz="1430779" rtl="0" eaLnBrk="1" latinLnBrk="0" hangingPunct="1">
        <a:spcBef>
          <a:spcPct val="20000"/>
        </a:spcBef>
        <a:buFont typeface="Arial" pitchFamily="34" charset="0"/>
        <a:buChar char="•"/>
        <a:defRPr sz="3130" kern="1200">
          <a:solidFill>
            <a:schemeClr val="tx1"/>
          </a:solidFill>
          <a:latin typeface="+mn-lt"/>
          <a:ea typeface="+mn-ea"/>
          <a:cs typeface="+mn-cs"/>
        </a:defRPr>
      </a:lvl7pPr>
      <a:lvl8pPr marL="5365420" indent="-357694" algn="l" defTabSz="1430779" rtl="0" eaLnBrk="1" latinLnBrk="0" hangingPunct="1">
        <a:spcBef>
          <a:spcPct val="20000"/>
        </a:spcBef>
        <a:buFont typeface="Arial" pitchFamily="34" charset="0"/>
        <a:buChar char="•"/>
        <a:defRPr sz="3130" kern="1200">
          <a:solidFill>
            <a:schemeClr val="tx1"/>
          </a:solidFill>
          <a:latin typeface="+mn-lt"/>
          <a:ea typeface="+mn-ea"/>
          <a:cs typeface="+mn-cs"/>
        </a:defRPr>
      </a:lvl8pPr>
      <a:lvl9pPr marL="6080808" indent="-357694" algn="l" defTabSz="1430779" rtl="0" eaLnBrk="1" latinLnBrk="0" hangingPunct="1">
        <a:spcBef>
          <a:spcPct val="20000"/>
        </a:spcBef>
        <a:buFont typeface="Arial" pitchFamily="34" charset="0"/>
        <a:buChar char="•"/>
        <a:defRPr sz="31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430779" rtl="0" eaLnBrk="1" latinLnBrk="0" hangingPunct="1">
        <a:defRPr sz="2817" kern="1200">
          <a:solidFill>
            <a:schemeClr val="tx1"/>
          </a:solidFill>
          <a:latin typeface="+mn-lt"/>
          <a:ea typeface="+mn-ea"/>
          <a:cs typeface="+mn-cs"/>
        </a:defRPr>
      </a:lvl1pPr>
      <a:lvl2pPr marL="715390" algn="l" defTabSz="1430779" rtl="0" eaLnBrk="1" latinLnBrk="0" hangingPunct="1">
        <a:defRPr sz="2817" kern="1200">
          <a:solidFill>
            <a:schemeClr val="tx1"/>
          </a:solidFill>
          <a:latin typeface="+mn-lt"/>
          <a:ea typeface="+mn-ea"/>
          <a:cs typeface="+mn-cs"/>
        </a:defRPr>
      </a:lvl2pPr>
      <a:lvl3pPr marL="1430779" algn="l" defTabSz="1430779" rtl="0" eaLnBrk="1" latinLnBrk="0" hangingPunct="1">
        <a:defRPr sz="2817" kern="1200">
          <a:solidFill>
            <a:schemeClr val="tx1"/>
          </a:solidFill>
          <a:latin typeface="+mn-lt"/>
          <a:ea typeface="+mn-ea"/>
          <a:cs typeface="+mn-cs"/>
        </a:defRPr>
      </a:lvl3pPr>
      <a:lvl4pPr marL="2146168" algn="l" defTabSz="1430779" rtl="0" eaLnBrk="1" latinLnBrk="0" hangingPunct="1">
        <a:defRPr sz="2817" kern="1200">
          <a:solidFill>
            <a:schemeClr val="tx1"/>
          </a:solidFill>
          <a:latin typeface="+mn-lt"/>
          <a:ea typeface="+mn-ea"/>
          <a:cs typeface="+mn-cs"/>
        </a:defRPr>
      </a:lvl4pPr>
      <a:lvl5pPr marL="2861557" algn="l" defTabSz="1430779" rtl="0" eaLnBrk="1" latinLnBrk="0" hangingPunct="1">
        <a:defRPr sz="2817" kern="1200">
          <a:solidFill>
            <a:schemeClr val="tx1"/>
          </a:solidFill>
          <a:latin typeface="+mn-lt"/>
          <a:ea typeface="+mn-ea"/>
          <a:cs typeface="+mn-cs"/>
        </a:defRPr>
      </a:lvl5pPr>
      <a:lvl6pPr marL="3576947" algn="l" defTabSz="1430779" rtl="0" eaLnBrk="1" latinLnBrk="0" hangingPunct="1">
        <a:defRPr sz="2817" kern="1200">
          <a:solidFill>
            <a:schemeClr val="tx1"/>
          </a:solidFill>
          <a:latin typeface="+mn-lt"/>
          <a:ea typeface="+mn-ea"/>
          <a:cs typeface="+mn-cs"/>
        </a:defRPr>
      </a:lvl6pPr>
      <a:lvl7pPr marL="4292336" algn="l" defTabSz="1430779" rtl="0" eaLnBrk="1" latinLnBrk="0" hangingPunct="1">
        <a:defRPr sz="2817" kern="1200">
          <a:solidFill>
            <a:schemeClr val="tx1"/>
          </a:solidFill>
          <a:latin typeface="+mn-lt"/>
          <a:ea typeface="+mn-ea"/>
          <a:cs typeface="+mn-cs"/>
        </a:defRPr>
      </a:lvl7pPr>
      <a:lvl8pPr marL="5007725" algn="l" defTabSz="1430779" rtl="0" eaLnBrk="1" latinLnBrk="0" hangingPunct="1">
        <a:defRPr sz="2817" kern="1200">
          <a:solidFill>
            <a:schemeClr val="tx1"/>
          </a:solidFill>
          <a:latin typeface="+mn-lt"/>
          <a:ea typeface="+mn-ea"/>
          <a:cs typeface="+mn-cs"/>
        </a:defRPr>
      </a:lvl8pPr>
      <a:lvl9pPr marL="5723114" algn="l" defTabSz="1430779" rtl="0" eaLnBrk="1" latinLnBrk="0" hangingPunct="1">
        <a:defRPr sz="28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1DF5322-877F-4705-BBEE-590B27FD08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880" y="1015043"/>
            <a:ext cx="2160000" cy="91362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4D3E2C22-3EE6-4DFF-B46E-C5898C7107F7}"/>
              </a:ext>
            </a:extLst>
          </p:cNvPr>
          <p:cNvSpPr txBox="1"/>
          <p:nvPr/>
        </p:nvSpPr>
        <p:spPr>
          <a:xfrm>
            <a:off x="-39239" y="-34716"/>
            <a:ext cx="14773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. S2</a:t>
            </a:r>
            <a:endParaRPr lang="zh-CN" altLang="en-US" sz="2800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72BBCE9-1D8D-47BD-93E2-2DCE245D4A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1031" y="2396840"/>
            <a:ext cx="2239652" cy="1116000"/>
          </a:xfrm>
          <a:prstGeom prst="rect">
            <a:avLst/>
          </a:prstGeom>
        </p:spPr>
      </p:pic>
      <p:grpSp>
        <p:nvGrpSpPr>
          <p:cNvPr id="26" name="组合 25">
            <a:extLst>
              <a:ext uri="{FF2B5EF4-FFF2-40B4-BE49-F238E27FC236}">
                <a16:creationId xmlns:a16="http://schemas.microsoft.com/office/drawing/2014/main" id="{32522CC9-4912-4F5F-80BD-BA17D72B16EE}"/>
              </a:ext>
            </a:extLst>
          </p:cNvPr>
          <p:cNvGrpSpPr>
            <a:grpSpLocks noChangeAspect="1"/>
          </p:cNvGrpSpPr>
          <p:nvPr/>
        </p:nvGrpSpPr>
        <p:grpSpPr>
          <a:xfrm>
            <a:off x="2781048" y="1333220"/>
            <a:ext cx="1080000" cy="451428"/>
            <a:chOff x="2417928" y="1420213"/>
            <a:chExt cx="1219591" cy="509776"/>
          </a:xfrm>
        </p:grpSpPr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A3AB97E0-4E32-424B-A20B-D798E093F0DC}"/>
                </a:ext>
              </a:extLst>
            </p:cNvPr>
            <p:cNvCxnSpPr>
              <a:cxnSpLocks/>
            </p:cNvCxnSpPr>
            <p:nvPr/>
          </p:nvCxnSpPr>
          <p:spPr>
            <a:xfrm>
              <a:off x="2417928" y="1425514"/>
              <a:ext cx="28803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06F58D1B-E0A6-4952-A110-D7A5455F9B15}"/>
                </a:ext>
              </a:extLst>
            </p:cNvPr>
            <p:cNvCxnSpPr>
              <a:cxnSpLocks/>
            </p:cNvCxnSpPr>
            <p:nvPr/>
          </p:nvCxnSpPr>
          <p:spPr>
            <a:xfrm>
              <a:off x="2698940" y="1420213"/>
              <a:ext cx="70628" cy="50845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DAEDB408-BB36-4D21-A0ED-A7ADE475C16D}"/>
                </a:ext>
              </a:extLst>
            </p:cNvPr>
            <p:cNvCxnSpPr>
              <a:cxnSpLocks/>
            </p:cNvCxnSpPr>
            <p:nvPr/>
          </p:nvCxnSpPr>
          <p:spPr>
            <a:xfrm>
              <a:off x="3349487" y="1420213"/>
              <a:ext cx="28803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D8805B3F-B215-412D-82BA-30A603349322}"/>
                </a:ext>
              </a:extLst>
            </p:cNvPr>
            <p:cNvCxnSpPr>
              <a:cxnSpLocks/>
            </p:cNvCxnSpPr>
            <p:nvPr/>
          </p:nvCxnSpPr>
          <p:spPr>
            <a:xfrm>
              <a:off x="2764631" y="1919288"/>
              <a:ext cx="53153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471ECAED-F9A2-4708-BF6D-1C0EAF2B372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88662" y="1421538"/>
              <a:ext cx="70628" cy="50845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987FBCA8-B149-4212-B3EA-EAB7F47205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33639" y="1661823"/>
              <a:ext cx="597958" cy="0"/>
            </a:xfrm>
            <a:prstGeom prst="line">
              <a:avLst/>
            </a:prstGeom>
            <a:ln w="19050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C6EC7A01-A092-4BBE-9989-ECF338BA60B3}"/>
              </a:ext>
            </a:extLst>
          </p:cNvPr>
          <p:cNvGrpSpPr>
            <a:grpSpLocks noChangeAspect="1"/>
          </p:cNvGrpSpPr>
          <p:nvPr/>
        </p:nvGrpSpPr>
        <p:grpSpPr>
          <a:xfrm>
            <a:off x="2781048" y="2719314"/>
            <a:ext cx="1080000" cy="422039"/>
            <a:chOff x="2575984" y="2236222"/>
            <a:chExt cx="925024" cy="361478"/>
          </a:xfrm>
        </p:grpSpPr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A18CACAF-FDAD-49E8-8DAF-8405DAADC0F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575984" y="2236222"/>
              <a:ext cx="925024" cy="361478"/>
              <a:chOff x="2575984" y="2236222"/>
              <a:chExt cx="925024" cy="361478"/>
            </a:xfrm>
          </p:grpSpPr>
          <p:cxnSp>
            <p:nvCxnSpPr>
              <p:cNvPr id="28" name="直接连接符 27">
                <a:extLst>
                  <a:ext uri="{FF2B5EF4-FFF2-40B4-BE49-F238E27FC236}">
                    <a16:creationId xmlns:a16="http://schemas.microsoft.com/office/drawing/2014/main" id="{50FECA41-91EF-429C-BA3E-57C95851C6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75984" y="2249682"/>
                <a:ext cx="204773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>
                <a:extLst>
                  <a:ext uri="{FF2B5EF4-FFF2-40B4-BE49-F238E27FC236}">
                    <a16:creationId xmlns:a16="http://schemas.microsoft.com/office/drawing/2014/main" id="{260ABCCD-05B2-476B-A523-2C26437EC50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775098" y="2245913"/>
                <a:ext cx="669" cy="343115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直接连接符 29">
                <a:extLst>
                  <a:ext uri="{FF2B5EF4-FFF2-40B4-BE49-F238E27FC236}">
                    <a16:creationId xmlns:a16="http://schemas.microsoft.com/office/drawing/2014/main" id="{A9E894CA-7129-424C-8B2B-262AE6A9ED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96235" y="2245913"/>
                <a:ext cx="204773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>
                <a:extLst>
                  <a:ext uri="{FF2B5EF4-FFF2-40B4-BE49-F238E27FC236}">
                    <a16:creationId xmlns:a16="http://schemas.microsoft.com/office/drawing/2014/main" id="{7E0FDFCD-DBB2-4D54-8B34-357BE8997D7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64465" y="2587018"/>
                <a:ext cx="541690" cy="201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4B4FF58B-AA31-4B07-9871-D597C172BB9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306155" y="2236222"/>
                <a:ext cx="0" cy="36147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A4AD2C6F-F776-4C62-9D05-26ED6D39BC61}"/>
                </a:ext>
              </a:extLst>
            </p:cNvPr>
            <p:cNvCxnSpPr>
              <a:cxnSpLocks/>
            </p:cNvCxnSpPr>
            <p:nvPr/>
          </p:nvCxnSpPr>
          <p:spPr>
            <a:xfrm>
              <a:off x="2780414" y="2395506"/>
              <a:ext cx="522790" cy="0"/>
            </a:xfrm>
            <a:prstGeom prst="line">
              <a:avLst/>
            </a:prstGeom>
            <a:ln w="19050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6250615B-630C-405C-9720-34F9EAC2D4E3}"/>
              </a:ext>
            </a:extLst>
          </p:cNvPr>
          <p:cNvCxnSpPr>
            <a:cxnSpLocks/>
          </p:cNvCxnSpPr>
          <p:nvPr/>
        </p:nvCxnSpPr>
        <p:spPr>
          <a:xfrm>
            <a:off x="2432165" y="1506723"/>
            <a:ext cx="360000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04AA8EBF-4FBE-4EEB-B537-3B5493783FD9}"/>
              </a:ext>
            </a:extLst>
          </p:cNvPr>
          <p:cNvSpPr txBox="1"/>
          <p:nvPr/>
        </p:nvSpPr>
        <p:spPr>
          <a:xfrm>
            <a:off x="1022531" y="1931167"/>
            <a:ext cx="11463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SC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箭头连接符 53">
            <a:extLst>
              <a:ext uri="{FF2B5EF4-FFF2-40B4-BE49-F238E27FC236}">
                <a16:creationId xmlns:a16="http://schemas.microsoft.com/office/drawing/2014/main" id="{42EB54BD-0705-47B3-A6C3-D3AA538385C2}"/>
              </a:ext>
            </a:extLst>
          </p:cNvPr>
          <p:cNvCxnSpPr>
            <a:cxnSpLocks/>
          </p:cNvCxnSpPr>
          <p:nvPr/>
        </p:nvCxnSpPr>
        <p:spPr>
          <a:xfrm>
            <a:off x="2414009" y="2900053"/>
            <a:ext cx="360000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48A39363-C1F1-4E40-B66D-61BF51FBF7B7}"/>
              </a:ext>
            </a:extLst>
          </p:cNvPr>
          <p:cNvSpPr txBox="1"/>
          <p:nvPr/>
        </p:nvSpPr>
        <p:spPr>
          <a:xfrm>
            <a:off x="2371694" y="1548206"/>
            <a:ext cx="6078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DEFABDA4-AB9D-4B82-90B7-AC7B15D1E067}"/>
              </a:ext>
            </a:extLst>
          </p:cNvPr>
          <p:cNvSpPr txBox="1"/>
          <p:nvPr/>
        </p:nvSpPr>
        <p:spPr>
          <a:xfrm>
            <a:off x="44624" y="3497045"/>
            <a:ext cx="24900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-Kit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D29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D49f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lowCD45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er119</a:t>
            </a:r>
            <a:r>
              <a:rPr lang="en-US" altLang="zh-CN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epatic stem cell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14D74F5-74FD-4013-9781-A5236D0B4EF7}"/>
              </a:ext>
            </a:extLst>
          </p:cNvPr>
          <p:cNvSpPr txBox="1"/>
          <p:nvPr/>
        </p:nvSpPr>
        <p:spPr>
          <a:xfrm>
            <a:off x="2373451" y="2925756"/>
            <a:ext cx="5792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806239C9-163B-4008-B97B-94A6C73ED085}"/>
              </a:ext>
            </a:extLst>
          </p:cNvPr>
          <p:cNvCxnSpPr>
            <a:cxnSpLocks/>
          </p:cNvCxnSpPr>
          <p:nvPr/>
        </p:nvCxnSpPr>
        <p:spPr>
          <a:xfrm flipV="1">
            <a:off x="3594434" y="1707764"/>
            <a:ext cx="122330" cy="494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303E0DB4-36B3-464E-AD3A-C248A302F918}"/>
              </a:ext>
            </a:extLst>
          </p:cNvPr>
          <p:cNvSpPr txBox="1"/>
          <p:nvPr/>
        </p:nvSpPr>
        <p:spPr>
          <a:xfrm>
            <a:off x="3644106" y="1580571"/>
            <a:ext cx="7798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0.4 </a:t>
            </a:r>
            <a:r>
              <a:rPr lang="en-US" altLang="zh-CN" sz="6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6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ore size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D570B774-D96A-40A8-B0E2-94ADEE7C73F7}"/>
              </a:ext>
            </a:extLst>
          </p:cNvPr>
          <p:cNvSpPr txBox="1"/>
          <p:nvPr/>
        </p:nvSpPr>
        <p:spPr>
          <a:xfrm>
            <a:off x="3662362" y="3179754"/>
            <a:ext cx="15481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  <a:r>
              <a:rPr lang="en-US" altLang="zh-CN" sz="6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ype IV collagen pre-coated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06E6DC43-D751-44CC-B803-F4F235512ECE}"/>
              </a:ext>
            </a:extLst>
          </p:cNvPr>
          <p:cNvSpPr txBox="1"/>
          <p:nvPr/>
        </p:nvSpPr>
        <p:spPr>
          <a:xfrm>
            <a:off x="4395855" y="2235329"/>
            <a:ext cx="5856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AB3FDA78-7B02-4D67-9B9A-F09EB44A5B13}"/>
              </a:ext>
            </a:extLst>
          </p:cNvPr>
          <p:cNvGrpSpPr>
            <a:grpSpLocks noChangeAspect="1"/>
          </p:cNvGrpSpPr>
          <p:nvPr/>
        </p:nvGrpSpPr>
        <p:grpSpPr>
          <a:xfrm>
            <a:off x="4887595" y="1927030"/>
            <a:ext cx="1080000" cy="451428"/>
            <a:chOff x="2417928" y="1420213"/>
            <a:chExt cx="1219591" cy="509776"/>
          </a:xfrm>
        </p:grpSpPr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8B8397B3-CF89-4BF7-909F-BBC0DBEADE1E}"/>
                </a:ext>
              </a:extLst>
            </p:cNvPr>
            <p:cNvCxnSpPr>
              <a:cxnSpLocks/>
            </p:cNvCxnSpPr>
            <p:nvPr/>
          </p:nvCxnSpPr>
          <p:spPr>
            <a:xfrm>
              <a:off x="2417928" y="1425514"/>
              <a:ext cx="28803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EB7CB08E-30B1-498C-80F5-3D11A3C13BEA}"/>
                </a:ext>
              </a:extLst>
            </p:cNvPr>
            <p:cNvCxnSpPr>
              <a:cxnSpLocks/>
            </p:cNvCxnSpPr>
            <p:nvPr/>
          </p:nvCxnSpPr>
          <p:spPr>
            <a:xfrm>
              <a:off x="2698940" y="1420213"/>
              <a:ext cx="70628" cy="50845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07665B85-9109-41F8-9035-5C531B8D097B}"/>
                </a:ext>
              </a:extLst>
            </p:cNvPr>
            <p:cNvCxnSpPr>
              <a:cxnSpLocks/>
            </p:cNvCxnSpPr>
            <p:nvPr/>
          </p:nvCxnSpPr>
          <p:spPr>
            <a:xfrm>
              <a:off x="3349487" y="1420213"/>
              <a:ext cx="28803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直接连接符 67">
              <a:extLst>
                <a:ext uri="{FF2B5EF4-FFF2-40B4-BE49-F238E27FC236}">
                  <a16:creationId xmlns:a16="http://schemas.microsoft.com/office/drawing/2014/main" id="{1774C061-8FDD-4DEA-BF8A-BD0B85624B52}"/>
                </a:ext>
              </a:extLst>
            </p:cNvPr>
            <p:cNvCxnSpPr>
              <a:cxnSpLocks/>
            </p:cNvCxnSpPr>
            <p:nvPr/>
          </p:nvCxnSpPr>
          <p:spPr>
            <a:xfrm>
              <a:off x="2764631" y="1919288"/>
              <a:ext cx="53153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直接连接符 68">
              <a:extLst>
                <a:ext uri="{FF2B5EF4-FFF2-40B4-BE49-F238E27FC236}">
                  <a16:creationId xmlns:a16="http://schemas.microsoft.com/office/drawing/2014/main" id="{0809B518-0B8E-4AD6-8FF9-22DF2E05240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88662" y="1421538"/>
              <a:ext cx="70628" cy="50845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304EE6C2-DBE0-43ED-9D45-1D903626B5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33639" y="1661823"/>
              <a:ext cx="597958" cy="0"/>
            </a:xfrm>
            <a:prstGeom prst="line">
              <a:avLst/>
            </a:prstGeom>
            <a:ln w="19050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918889F9-96B0-406E-AB1E-9ACEE7F9AF1E}"/>
              </a:ext>
            </a:extLst>
          </p:cNvPr>
          <p:cNvGrpSpPr>
            <a:grpSpLocks noChangeAspect="1"/>
          </p:cNvGrpSpPr>
          <p:nvPr/>
        </p:nvGrpSpPr>
        <p:grpSpPr>
          <a:xfrm>
            <a:off x="4888095" y="2005792"/>
            <a:ext cx="1080000" cy="422039"/>
            <a:chOff x="2575984" y="2236222"/>
            <a:chExt cx="925024" cy="361478"/>
          </a:xfrm>
        </p:grpSpPr>
        <p:cxnSp>
          <p:nvCxnSpPr>
            <p:cNvPr id="74" name="直接连接符 73">
              <a:extLst>
                <a:ext uri="{FF2B5EF4-FFF2-40B4-BE49-F238E27FC236}">
                  <a16:creationId xmlns:a16="http://schemas.microsoft.com/office/drawing/2014/main" id="{1F6BAE8D-F594-4689-BAB7-7BA995E69E3C}"/>
                </a:ext>
              </a:extLst>
            </p:cNvPr>
            <p:cNvCxnSpPr>
              <a:cxnSpLocks/>
            </p:cNvCxnSpPr>
            <p:nvPr/>
          </p:nvCxnSpPr>
          <p:spPr>
            <a:xfrm>
              <a:off x="2575984" y="2249682"/>
              <a:ext cx="204773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E3013068-4E81-43BB-A61A-C4E53AC575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75098" y="2245913"/>
              <a:ext cx="669" cy="34311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468FDEC3-657B-4B22-9ADF-20B8159D767F}"/>
                </a:ext>
              </a:extLst>
            </p:cNvPr>
            <p:cNvCxnSpPr>
              <a:cxnSpLocks/>
            </p:cNvCxnSpPr>
            <p:nvPr/>
          </p:nvCxnSpPr>
          <p:spPr>
            <a:xfrm>
              <a:off x="3296235" y="2245913"/>
              <a:ext cx="204773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C42FE3BA-EA02-4F15-AD32-2C8C00F497B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64465" y="2587018"/>
              <a:ext cx="541690" cy="201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64D34430-C800-402F-B617-A4D6D704E2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06155" y="2236222"/>
              <a:ext cx="0" cy="361478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80" name="连接符: 肘形 79">
            <a:extLst>
              <a:ext uri="{FF2B5EF4-FFF2-40B4-BE49-F238E27FC236}">
                <a16:creationId xmlns:a16="http://schemas.microsoft.com/office/drawing/2014/main" id="{291B1FA3-03C8-4A4E-AC7F-A63FDCD18832}"/>
              </a:ext>
            </a:extLst>
          </p:cNvPr>
          <p:cNvCxnSpPr>
            <a:cxnSpLocks/>
          </p:cNvCxnSpPr>
          <p:nvPr/>
        </p:nvCxnSpPr>
        <p:spPr>
          <a:xfrm>
            <a:off x="4077072" y="1479166"/>
            <a:ext cx="749076" cy="728503"/>
          </a:xfrm>
          <a:prstGeom prst="bentConnector3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连接符: 肘形 81">
            <a:extLst>
              <a:ext uri="{FF2B5EF4-FFF2-40B4-BE49-F238E27FC236}">
                <a16:creationId xmlns:a16="http://schemas.microsoft.com/office/drawing/2014/main" id="{BAB222E6-6ED3-4AED-AAFD-EBC5611F5EC7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3950402" y="2385925"/>
            <a:ext cx="679704" cy="323191"/>
          </a:xfrm>
          <a:prstGeom prst="bentConnector3">
            <a:avLst>
              <a:gd name="adj1" fmla="val 94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57E2F1D7-7113-4CAF-9B96-18F28DE8ACD7}"/>
              </a:ext>
            </a:extLst>
          </p:cNvPr>
          <p:cNvCxnSpPr>
            <a:cxnSpLocks/>
          </p:cNvCxnSpPr>
          <p:nvPr/>
        </p:nvCxnSpPr>
        <p:spPr>
          <a:xfrm flipH="1">
            <a:off x="5419108" y="2152157"/>
            <a:ext cx="476348" cy="18850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945F4109-20C6-4362-8D61-3535425BAF4C}"/>
              </a:ext>
            </a:extLst>
          </p:cNvPr>
          <p:cNvSpPr txBox="1"/>
          <p:nvPr/>
        </p:nvSpPr>
        <p:spPr>
          <a:xfrm>
            <a:off x="5843175" y="2025216"/>
            <a:ext cx="525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SC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128BBA97-C00C-4468-A616-4AD39EE805BD}"/>
              </a:ext>
            </a:extLst>
          </p:cNvPr>
          <p:cNvCxnSpPr>
            <a:cxnSpLocks/>
          </p:cNvCxnSpPr>
          <p:nvPr/>
        </p:nvCxnSpPr>
        <p:spPr>
          <a:xfrm flipH="1">
            <a:off x="5447230" y="2330450"/>
            <a:ext cx="525825" cy="7153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id="{755183EE-4EF3-458C-8B5B-03D6D5811A98}"/>
              </a:ext>
            </a:extLst>
          </p:cNvPr>
          <p:cNvSpPr txBox="1"/>
          <p:nvPr/>
        </p:nvSpPr>
        <p:spPr>
          <a:xfrm>
            <a:off x="5909151" y="2181396"/>
            <a:ext cx="1107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epatic stem cell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A1AF4E04-E0BE-425F-A167-6A01BFC3C22A}"/>
              </a:ext>
            </a:extLst>
          </p:cNvPr>
          <p:cNvSpPr txBox="1"/>
          <p:nvPr/>
        </p:nvSpPr>
        <p:spPr>
          <a:xfrm>
            <a:off x="2011208" y="1697450"/>
            <a:ext cx="4255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>
                    <a:lumMod val="9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µm</a:t>
            </a:r>
            <a:endParaRPr lang="zh-CN" altLang="en-US" sz="600" dirty="0">
              <a:solidFill>
                <a:schemeClr val="bg1">
                  <a:lumMod val="9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BF3AAA03-1BB7-4712-9EBA-D18C6151A5AC}"/>
              </a:ext>
            </a:extLst>
          </p:cNvPr>
          <p:cNvSpPr txBox="1"/>
          <p:nvPr/>
        </p:nvSpPr>
        <p:spPr>
          <a:xfrm>
            <a:off x="5028348" y="2493700"/>
            <a:ext cx="8377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713F86EE-1F0D-4D91-8E3A-9E3057B78858}"/>
              </a:ext>
            </a:extLst>
          </p:cNvPr>
          <p:cNvSpPr txBox="1"/>
          <p:nvPr/>
        </p:nvSpPr>
        <p:spPr>
          <a:xfrm>
            <a:off x="2865592" y="1839460"/>
            <a:ext cx="9996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 insert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E7634BE3-E563-4C9C-ADAC-05864D168225}"/>
              </a:ext>
            </a:extLst>
          </p:cNvPr>
          <p:cNvSpPr txBox="1"/>
          <p:nvPr/>
        </p:nvSpPr>
        <p:spPr>
          <a:xfrm>
            <a:off x="2972579" y="3199711"/>
            <a:ext cx="760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6-well plate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直接连接符 111">
            <a:extLst>
              <a:ext uri="{FF2B5EF4-FFF2-40B4-BE49-F238E27FC236}">
                <a16:creationId xmlns:a16="http://schemas.microsoft.com/office/drawing/2014/main" id="{AA386C55-01DD-49CF-9B4E-FBE8CCA6D0EF}"/>
              </a:ext>
            </a:extLst>
          </p:cNvPr>
          <p:cNvCxnSpPr>
            <a:cxnSpLocks/>
          </p:cNvCxnSpPr>
          <p:nvPr/>
        </p:nvCxnSpPr>
        <p:spPr>
          <a:xfrm>
            <a:off x="3662362" y="3110885"/>
            <a:ext cx="79146" cy="10713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30213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85</TotalTime>
  <Words>41</Words>
  <Application>Microsoft Office PowerPoint</Application>
  <PresentationFormat>A4 纸张(210x297 毫米)</PresentationFormat>
  <Paragraphs>1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nyun Ge</dc:creator>
  <cp:lastModifiedBy>Jianyun Ge</cp:lastModifiedBy>
  <cp:revision>130</cp:revision>
  <dcterms:created xsi:type="dcterms:W3CDTF">2019-12-21T03:14:22Z</dcterms:created>
  <dcterms:modified xsi:type="dcterms:W3CDTF">2020-07-20T08:41:42Z</dcterms:modified>
</cp:coreProperties>
</file>